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3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47" userDrawn="1">
          <p15:clr>
            <a:srgbClr val="A4A3A4"/>
          </p15:clr>
        </p15:guide>
        <p15:guide id="2" pos="5103" userDrawn="1">
          <p15:clr>
            <a:srgbClr val="A4A3A4"/>
          </p15:clr>
        </p15:guide>
        <p15:guide id="3" pos="1633" userDrawn="1">
          <p15:clr>
            <a:srgbClr val="A4A3A4"/>
          </p15:clr>
        </p15:guide>
        <p15:guide id="4" orient="horz" pos="2636" userDrawn="1">
          <p15:clr>
            <a:srgbClr val="A4A3A4"/>
          </p15:clr>
        </p15:guide>
        <p15:guide id="5" orient="horz" pos="33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71" autoAdjust="0"/>
    <p:restoredTop sz="72410" autoAdjust="0"/>
  </p:normalViewPr>
  <p:slideViewPr>
    <p:cSldViewPr snapToGrid="0" showGuides="1">
      <p:cViewPr varScale="1">
        <p:scale>
          <a:sx n="59" d="100"/>
          <a:sy n="59" d="100"/>
        </p:scale>
        <p:origin x="2362" y="58"/>
      </p:cViewPr>
      <p:guideLst>
        <p:guide orient="horz" pos="4247"/>
        <p:guide pos="5103"/>
        <p:guide pos="1633"/>
        <p:guide orient="horz" pos="2636"/>
        <p:guide orient="horz" pos="33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C91D8C-BE3E-4B82-8C37-D03BB2CF31D9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AAEED6-4AA4-4647-8660-DCFE40CCA8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51543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536BDF-77A6-47D1-B010-EF7FFD7E29C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630EBE-8035-4B81-A383-54D40CAC77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53488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630EBE-8035-4B81-A383-54D40CAC77F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66957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3247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8380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2713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1699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4121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5978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273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5419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88482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0379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3729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2865C-2B1C-4F8C-97B2-4988FD0FDA90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17B3DC-A3F7-4FD4-97CF-666279C76F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8427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1231209" y="1770588"/>
            <a:ext cx="626415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tention time, calibration equation, and correlation coefficient for compound in extracts of </a:t>
            </a:r>
          </a:p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illa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utescens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. </a:t>
            </a:r>
            <a:r>
              <a:rPr lang="en-US" altLang="ko-K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uta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dash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Kudo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ves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</a:t>
            </a: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1533567" y="2222204"/>
            <a:ext cx="3408305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377"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ko-KR" altLang="ko-KR" sz="400" dirty="0">
                <a:latin typeface="Arial" panose="020B0604020202020204" pitchFamily="34" charset="0"/>
              </a:rPr>
            </a:br>
            <a:endParaRPr lang="ko-KR" altLang="ko-KR" sz="1200" dirty="0">
              <a:latin typeface="Arial" panose="020B0604020202020204" pitchFamily="34" charset="0"/>
              <a:cs typeface="굴림" panose="020B0600000101010101" pitchFamily="50" charset="-127"/>
            </a:endParaRPr>
          </a:p>
          <a:p>
            <a:pPr defTabSz="914377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a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y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: peak area, 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x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: concentration of standards (mg/ml).</a:t>
            </a:r>
            <a:endParaRPr lang="en-US" altLang="ko-KR" sz="400" dirty="0"/>
          </a:p>
          <a:p>
            <a:pPr defTabSz="914377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ko-KR" dirty="0">
              <a:latin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2BE7D8F-C87B-4A61-8C9B-3259CAB12220}"/>
              </a:ext>
            </a:extLst>
          </p:cNvPr>
          <p:cNvSpPr txBox="1"/>
          <p:nvPr/>
        </p:nvSpPr>
        <p:spPr>
          <a:xfrm>
            <a:off x="8102807" y="0"/>
            <a:ext cx="10488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itchFamily="34" charset="0"/>
                <a:cs typeface="Arial" pitchFamily="34" charset="0"/>
              </a:rPr>
              <a:t>Table 1</a:t>
            </a:r>
            <a:endParaRPr lang="ko-KR" altLang="en-US" sz="20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id="{DF189204-E253-413E-A498-5BC5F7052D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3024958"/>
              </p:ext>
            </p:extLst>
          </p:nvPr>
        </p:nvGraphicFramePr>
        <p:xfrm>
          <a:off x="1092954" y="2847518"/>
          <a:ext cx="6958092" cy="828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739523">
                  <a:extLst>
                    <a:ext uri="{9D8B030D-6E8A-4147-A177-3AD203B41FA5}">
                      <a16:colId xmlns:a16="http://schemas.microsoft.com/office/drawing/2014/main" val="2223981660"/>
                    </a:ext>
                  </a:extLst>
                </a:gridCol>
                <a:gridCol w="1739523">
                  <a:extLst>
                    <a:ext uri="{9D8B030D-6E8A-4147-A177-3AD203B41FA5}">
                      <a16:colId xmlns:a16="http://schemas.microsoft.com/office/drawing/2014/main" val="3695013583"/>
                    </a:ext>
                  </a:extLst>
                </a:gridCol>
                <a:gridCol w="1739523">
                  <a:extLst>
                    <a:ext uri="{9D8B030D-6E8A-4147-A177-3AD203B41FA5}">
                      <a16:colId xmlns:a16="http://schemas.microsoft.com/office/drawing/2014/main" val="41491703"/>
                    </a:ext>
                  </a:extLst>
                </a:gridCol>
                <a:gridCol w="1739523">
                  <a:extLst>
                    <a:ext uri="{9D8B030D-6E8A-4147-A177-3AD203B41FA5}">
                      <a16:colId xmlns:a16="http://schemas.microsoft.com/office/drawing/2014/main" val="377166954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und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tention time (min)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ibration equation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 (r</a:t>
                      </a:r>
                      <a:r>
                        <a:rPr lang="en-US" altLang="ko-KR" sz="12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664148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smarinic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id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45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57.769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215.25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351080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56620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80</TotalTime>
  <Words>66</Words>
  <Application>Microsoft Office PowerPoint</Application>
  <PresentationFormat>화면 슬라이드 쇼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MS PGothic</vt:lpstr>
      <vt:lpstr>굴림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joumc</dc:creator>
  <cp:lastModifiedBy>cholong</cp:lastModifiedBy>
  <cp:revision>236</cp:revision>
  <cp:lastPrinted>2020-11-26T01:56:24Z</cp:lastPrinted>
  <dcterms:created xsi:type="dcterms:W3CDTF">2020-02-03T05:37:08Z</dcterms:created>
  <dcterms:modified xsi:type="dcterms:W3CDTF">2021-01-13T02:09:21Z</dcterms:modified>
</cp:coreProperties>
</file>